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9"/>
  </p:notesMasterIdLst>
  <p:sldIdLst>
    <p:sldId id="261" r:id="rId2"/>
    <p:sldId id="262" r:id="rId3"/>
    <p:sldId id="263" r:id="rId4"/>
    <p:sldId id="264" r:id="rId5"/>
    <p:sldId id="266" r:id="rId6"/>
    <p:sldId id="267" r:id="rId7"/>
    <p:sldId id="265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29" userDrawn="1">
          <p15:clr>
            <a:srgbClr val="A4A3A4"/>
          </p15:clr>
        </p15:guide>
        <p15:guide id="2" orient="horz" pos="2485" userDrawn="1">
          <p15:clr>
            <a:srgbClr val="A4A3A4"/>
          </p15:clr>
        </p15:guide>
        <p15:guide id="4" pos="1820" userDrawn="1">
          <p15:clr>
            <a:srgbClr val="A4A3A4"/>
          </p15:clr>
        </p15:guide>
        <p15:guide id="5" pos="3680" userDrawn="1">
          <p15:clr>
            <a:srgbClr val="A4A3A4"/>
          </p15:clr>
        </p15:guide>
        <p15:guide id="6" orient="horz" pos="4186" userDrawn="1">
          <p15:clr>
            <a:srgbClr val="A4A3A4"/>
          </p15:clr>
        </p15:guide>
        <p15:guide id="7" pos="414" userDrawn="1">
          <p15:clr>
            <a:srgbClr val="A4A3A4"/>
          </p15:clr>
        </p15:guide>
        <p15:guide id="8" orient="horz" pos="62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283"/>
    <p:restoredTop sz="95934"/>
  </p:normalViewPr>
  <p:slideViewPr>
    <p:cSldViewPr snapToGrid="0">
      <p:cViewPr>
        <p:scale>
          <a:sx n="123" d="100"/>
          <a:sy n="123" d="100"/>
        </p:scale>
        <p:origin x="2064" y="-280"/>
      </p:cViewPr>
      <p:guideLst>
        <p:guide orient="horz" pos="829"/>
        <p:guide orient="horz" pos="2485"/>
        <p:guide pos="1820"/>
        <p:guide pos="3680"/>
        <p:guide orient="horz" pos="4186"/>
        <p:guide pos="414"/>
        <p:guide orient="horz" pos="6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66DF2D-3FAB-974E-890D-9636E1B58292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715DC4-6B69-584D-928A-F56EBCFA56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37799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  <a:spcAft>
                <a:spcPts val="800"/>
              </a:spcAft>
            </a:pPr>
            <a:r>
              <a:rPr lang="it-IT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</a:t>
            </a:r>
            <a:r>
              <a:rPr lang="it-IT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Figure 1 A. </a:t>
            </a:r>
            <a:r>
              <a:rPr lang="it-IT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dPCR</a:t>
            </a:r>
            <a:r>
              <a:rPr lang="it-IT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opies/</a:t>
            </a:r>
            <a:r>
              <a:rPr lang="it-IT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μL</a:t>
            </a:r>
            <a:r>
              <a:rPr lang="it-IT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f SFF in 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C patients classified for TNM staging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d 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ealthy donors (HD) plasma samples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varege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alue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black line).</a:t>
            </a:r>
            <a:r>
              <a:rPr lang="it-IT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5, 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1, *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01, **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001.</a:t>
            </a:r>
            <a:r>
              <a:rPr lang="it-IT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B. </a:t>
            </a:r>
            <a:r>
              <a:rPr lang="it-IT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dPCR</a:t>
            </a:r>
            <a:r>
              <a:rPr lang="it-IT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opies/</a:t>
            </a:r>
            <a:r>
              <a:rPr lang="it-IT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μL</a:t>
            </a:r>
            <a:r>
              <a:rPr lang="it-IT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f 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GMT_623CG methylated region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C patients classified for TNM staging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d 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ealthy donors (HD) plasma samples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varege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alue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black line). 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5, 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1, *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01, **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001. </a:t>
            </a:r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715DC4-6B69-584D-928A-F56EBCFA56D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65793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lnSpc>
                <a:spcPct val="150000"/>
              </a:lnSpc>
              <a:spcAft>
                <a:spcPts val="800"/>
              </a:spcAft>
            </a:pPr>
            <a:r>
              <a:rPr lang="it-IT" sz="1800" b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</a:t>
            </a:r>
            <a:r>
              <a:rPr lang="it-IT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Figure 1 A. </a:t>
            </a:r>
            <a:r>
              <a:rPr lang="it-IT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dPCR</a:t>
            </a:r>
            <a:r>
              <a:rPr lang="it-IT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opies/</a:t>
            </a:r>
            <a:r>
              <a:rPr lang="it-IT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μL</a:t>
            </a:r>
            <a:r>
              <a:rPr lang="it-IT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f SFF in 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C patients classified for TNM staging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d 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ealthy donors (HD) plasma samples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varege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alue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black line).</a:t>
            </a:r>
            <a:r>
              <a:rPr lang="it-IT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5, 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1, *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01, **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001.</a:t>
            </a:r>
            <a:r>
              <a:rPr lang="it-IT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B. </a:t>
            </a:r>
            <a:r>
              <a:rPr lang="it-IT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dPCR</a:t>
            </a:r>
            <a:r>
              <a:rPr lang="it-IT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opies/</a:t>
            </a:r>
            <a:r>
              <a:rPr lang="it-IT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μL</a:t>
            </a:r>
            <a:r>
              <a:rPr lang="it-IT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f 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GMT_623CG methylated region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C patients classified for TNM staging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d </a:t>
            </a:r>
            <a:r>
              <a:rPr lang="en-US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ealthy donors (HD) plasma samples 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varege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alue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black line). 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5, 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1, *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01, **** </a:t>
            </a:r>
            <a:r>
              <a:rPr lang="it-IT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it-IT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0.0001. </a:t>
            </a:r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715DC4-6B69-584D-928A-F56EBCFA56DC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55815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4831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6393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9135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2822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4038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090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571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95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5763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7515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399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7746D-602E-9441-A259-A359ABF6D263}" type="datetimeFigureOut">
              <a:rPr lang="en-GB" smtClean="0"/>
              <a:t>31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B3F38-3106-E94F-A349-C1BB2193CDA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6598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D28F628F-D060-AEFE-6B01-60C398528DB6}"/>
              </a:ext>
            </a:extLst>
          </p:cNvPr>
          <p:cNvSpPr txBox="1"/>
          <p:nvPr/>
        </p:nvSpPr>
        <p:spPr>
          <a:xfrm>
            <a:off x="215991" y="845776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54F8601-E3CA-5628-67E9-518499FCAE44}"/>
              </a:ext>
            </a:extLst>
          </p:cNvPr>
          <p:cNvSpPr txBox="1"/>
          <p:nvPr/>
        </p:nvSpPr>
        <p:spPr>
          <a:xfrm>
            <a:off x="1539430" y="12675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CasellaDiTesto 7">
            <a:extLst>
              <a:ext uri="{FF2B5EF4-FFF2-40B4-BE49-F238E27FC236}">
                <a16:creationId xmlns:a16="http://schemas.microsoft.com/office/drawing/2014/main" id="{5D739A0A-FAF3-2E4E-93F3-A6A55F579D73}"/>
              </a:ext>
            </a:extLst>
          </p:cNvPr>
          <p:cNvSpPr txBox="1"/>
          <p:nvPr/>
        </p:nvSpPr>
        <p:spPr>
          <a:xfrm>
            <a:off x="1539430" y="384137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75639A2-1EDF-2D49-88A2-92431DF14D4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0314"/>
          <a:stretch/>
        </p:blipFill>
        <p:spPr>
          <a:xfrm>
            <a:off x="1777842" y="4180361"/>
            <a:ext cx="2844800" cy="254000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CBD0E2D-EDDA-F449-9AFE-57780EF5D1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11708" y="1462929"/>
            <a:ext cx="31115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86831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D28F628F-D060-AEFE-6B01-60C398528DB6}"/>
              </a:ext>
            </a:extLst>
          </p:cNvPr>
          <p:cNvSpPr txBox="1"/>
          <p:nvPr/>
        </p:nvSpPr>
        <p:spPr>
          <a:xfrm>
            <a:off x="215991" y="680792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54F8601-E3CA-5628-67E9-518499FCAE44}"/>
              </a:ext>
            </a:extLst>
          </p:cNvPr>
          <p:cNvSpPr txBox="1"/>
          <p:nvPr/>
        </p:nvSpPr>
        <p:spPr>
          <a:xfrm>
            <a:off x="1539430" y="12675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CasellaDiTesto 7">
            <a:extLst>
              <a:ext uri="{FF2B5EF4-FFF2-40B4-BE49-F238E27FC236}">
                <a16:creationId xmlns:a16="http://schemas.microsoft.com/office/drawing/2014/main" id="{5D739A0A-FAF3-2E4E-93F3-A6A55F579D73}"/>
              </a:ext>
            </a:extLst>
          </p:cNvPr>
          <p:cNvSpPr txBox="1"/>
          <p:nvPr/>
        </p:nvSpPr>
        <p:spPr>
          <a:xfrm>
            <a:off x="1539430" y="395990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8A01EC0-A89A-BF4E-9369-9FFA44114BE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3043"/>
          <a:stretch/>
        </p:blipFill>
        <p:spPr>
          <a:xfrm>
            <a:off x="1760538" y="4267684"/>
            <a:ext cx="3048000" cy="254001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35BA48F-0060-754F-B602-21E1D4E3E7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4404" y="1169571"/>
            <a:ext cx="2819400" cy="279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7073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4">
            <a:extLst>
              <a:ext uri="{FF2B5EF4-FFF2-40B4-BE49-F238E27FC236}">
                <a16:creationId xmlns:a16="http://schemas.microsoft.com/office/drawing/2014/main" id="{CF7E49B8-96CC-164C-A5E8-B73B24D361EA}"/>
              </a:ext>
            </a:extLst>
          </p:cNvPr>
          <p:cNvSpPr txBox="1"/>
          <p:nvPr/>
        </p:nvSpPr>
        <p:spPr>
          <a:xfrm>
            <a:off x="349067" y="402430"/>
            <a:ext cx="2540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71AEFB98-572C-4442-A81A-4E560AF3C3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1554758"/>
              </p:ext>
            </p:extLst>
          </p:nvPr>
        </p:nvGraphicFramePr>
        <p:xfrm>
          <a:off x="471486" y="771762"/>
          <a:ext cx="5915027" cy="3190628"/>
        </p:xfrm>
        <a:graphic>
          <a:graphicData uri="http://schemas.openxmlformats.org/drawingml/2006/table">
            <a:tbl>
              <a:tblPr/>
              <a:tblGrid>
                <a:gridCol w="442914">
                  <a:extLst>
                    <a:ext uri="{9D8B030D-6E8A-4147-A177-3AD203B41FA5}">
                      <a16:colId xmlns:a16="http://schemas.microsoft.com/office/drawing/2014/main" val="1007689069"/>
                    </a:ext>
                  </a:extLst>
                </a:gridCol>
                <a:gridCol w="406400">
                  <a:extLst>
                    <a:ext uri="{9D8B030D-6E8A-4147-A177-3AD203B41FA5}">
                      <a16:colId xmlns:a16="http://schemas.microsoft.com/office/drawing/2014/main" val="3339244855"/>
                    </a:ext>
                  </a:extLst>
                </a:gridCol>
                <a:gridCol w="320431">
                  <a:extLst>
                    <a:ext uri="{9D8B030D-6E8A-4147-A177-3AD203B41FA5}">
                      <a16:colId xmlns:a16="http://schemas.microsoft.com/office/drawing/2014/main" val="2546229834"/>
                    </a:ext>
                  </a:extLst>
                </a:gridCol>
                <a:gridCol w="789354">
                  <a:extLst>
                    <a:ext uri="{9D8B030D-6E8A-4147-A177-3AD203B41FA5}">
                      <a16:colId xmlns:a16="http://schemas.microsoft.com/office/drawing/2014/main" val="2843725449"/>
                    </a:ext>
                  </a:extLst>
                </a:gridCol>
                <a:gridCol w="679938">
                  <a:extLst>
                    <a:ext uri="{9D8B030D-6E8A-4147-A177-3AD203B41FA5}">
                      <a16:colId xmlns:a16="http://schemas.microsoft.com/office/drawing/2014/main" val="4215715458"/>
                    </a:ext>
                  </a:extLst>
                </a:gridCol>
                <a:gridCol w="668346">
                  <a:extLst>
                    <a:ext uri="{9D8B030D-6E8A-4147-A177-3AD203B41FA5}">
                      <a16:colId xmlns:a16="http://schemas.microsoft.com/office/drawing/2014/main" val="530540012"/>
                    </a:ext>
                  </a:extLst>
                </a:gridCol>
                <a:gridCol w="620457">
                  <a:extLst>
                    <a:ext uri="{9D8B030D-6E8A-4147-A177-3AD203B41FA5}">
                      <a16:colId xmlns:a16="http://schemas.microsoft.com/office/drawing/2014/main" val="1552697153"/>
                    </a:ext>
                  </a:extLst>
                </a:gridCol>
                <a:gridCol w="648033">
                  <a:extLst>
                    <a:ext uri="{9D8B030D-6E8A-4147-A177-3AD203B41FA5}">
                      <a16:colId xmlns:a16="http://schemas.microsoft.com/office/drawing/2014/main" val="1554845693"/>
                    </a:ext>
                  </a:extLst>
                </a:gridCol>
                <a:gridCol w="635969">
                  <a:extLst>
                    <a:ext uri="{9D8B030D-6E8A-4147-A177-3AD203B41FA5}">
                      <a16:colId xmlns:a16="http://schemas.microsoft.com/office/drawing/2014/main" val="2273724965"/>
                    </a:ext>
                  </a:extLst>
                </a:gridCol>
                <a:gridCol w="703185">
                  <a:extLst>
                    <a:ext uri="{9D8B030D-6E8A-4147-A177-3AD203B41FA5}">
                      <a16:colId xmlns:a16="http://schemas.microsoft.com/office/drawing/2014/main" val="3238908759"/>
                    </a:ext>
                  </a:extLst>
                </a:gridCol>
              </a:tblGrid>
              <a:tr h="4063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D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x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e 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utation status RET/HRA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N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lcitonin (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g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ml) 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alysis </a:t>
                      </a:r>
                    </a:p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e-surger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alysis at follow up </a:t>
                      </a:r>
                    </a:p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m - y)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us at last follow up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ype of analysis (F/M)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15728142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-1-2 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 N1a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,4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,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73894809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-15-1 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RA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bN0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5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,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839913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-88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N1bM1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92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ease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,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8044630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-107-1 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A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bN0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22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,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93544368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-26-T0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A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aN1a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,2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4928391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-20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bN1b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60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,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28353910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-1-1 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K3CA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N1M1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ease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,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71534783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-11-1 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6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3N1MX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54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ease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,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0748166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-14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RA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AN0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0,7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 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78208256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-18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3N1b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3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IT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cease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05479507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-61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bN0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gt;5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0103945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-64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 W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N1a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24132122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-65-2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6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 W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3aN1b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48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1455375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-87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 W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N1b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26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97460407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-92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xmN1b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4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22916765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-94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 W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3N1b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5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0871042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-2-3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 W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N0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46912196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-4-3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 W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N0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2655064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-5-3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T WT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N0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5916218"/>
                  </a:ext>
                </a:extLst>
              </a:tr>
              <a:tr h="139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-8-1</a:t>
                      </a:r>
                    </a:p>
                  </a:txBody>
                  <a:tcPr marL="5177" marR="5177" marT="51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1N0M0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 y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</a:t>
                      </a:r>
                    </a:p>
                  </a:txBody>
                  <a:tcPr marL="5177" marR="5177" marT="517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8585690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6FEF2B25-70D9-914D-9EF2-BF34DFC189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4326739"/>
              </p:ext>
            </p:extLst>
          </p:nvPr>
        </p:nvGraphicFramePr>
        <p:xfrm>
          <a:off x="471486" y="4199207"/>
          <a:ext cx="1482360" cy="1092200"/>
        </p:xfrm>
        <a:graphic>
          <a:graphicData uri="http://schemas.openxmlformats.org/drawingml/2006/table">
            <a:tbl>
              <a:tblPr/>
              <a:tblGrid>
                <a:gridCol w="1482360">
                  <a:extLst>
                    <a:ext uri="{9D8B030D-6E8A-4147-A177-3AD203B41FA5}">
                      <a16:colId xmlns:a16="http://schemas.microsoft.com/office/drawing/2014/main" val="3191820840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F: disease-fre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15589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D: biochemical disea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957673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D: structural disea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501881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endParaRPr lang="en-IT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478028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= Fragment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916487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= Methylation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43853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958739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4">
            <a:extLst>
              <a:ext uri="{FF2B5EF4-FFF2-40B4-BE49-F238E27FC236}">
                <a16:creationId xmlns:a16="http://schemas.microsoft.com/office/drawing/2014/main" id="{26B8C112-CE50-7D4F-BD67-34BF60BB9CAD}"/>
              </a:ext>
            </a:extLst>
          </p:cNvPr>
          <p:cNvSpPr txBox="1"/>
          <p:nvPr/>
        </p:nvSpPr>
        <p:spPr>
          <a:xfrm>
            <a:off x="657225" y="1131372"/>
            <a:ext cx="2540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9DEC2B4-804A-5641-AA9E-F4B54738AF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4838532"/>
              </p:ext>
            </p:extLst>
          </p:nvPr>
        </p:nvGraphicFramePr>
        <p:xfrm>
          <a:off x="1621368" y="1574883"/>
          <a:ext cx="1939979" cy="868380"/>
        </p:xfrm>
        <a:graphic>
          <a:graphicData uri="http://schemas.openxmlformats.org/drawingml/2006/table">
            <a:tbl>
              <a:tblPr/>
              <a:tblGrid>
                <a:gridCol w="618846">
                  <a:extLst>
                    <a:ext uri="{9D8B030D-6E8A-4147-A177-3AD203B41FA5}">
                      <a16:colId xmlns:a16="http://schemas.microsoft.com/office/drawing/2014/main" val="4191654769"/>
                    </a:ext>
                  </a:extLst>
                </a:gridCol>
                <a:gridCol w="618846">
                  <a:extLst>
                    <a:ext uri="{9D8B030D-6E8A-4147-A177-3AD203B41FA5}">
                      <a16:colId xmlns:a16="http://schemas.microsoft.com/office/drawing/2014/main" val="699789826"/>
                    </a:ext>
                  </a:extLst>
                </a:gridCol>
                <a:gridCol w="702287">
                  <a:extLst>
                    <a:ext uri="{9D8B030D-6E8A-4147-A177-3AD203B41FA5}">
                      <a16:colId xmlns:a16="http://schemas.microsoft.com/office/drawing/2014/main" val="2086382808"/>
                    </a:ext>
                  </a:extLst>
                </a:gridCol>
              </a:tblGrid>
              <a:tr h="144730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lthy donors (n=20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9471857"/>
                  </a:ext>
                </a:extLst>
              </a:tr>
              <a:tr h="14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x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=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9610325"/>
                  </a:ext>
                </a:extLst>
              </a:tr>
              <a:tr h="144730">
                <a:tc>
                  <a:txBody>
                    <a:bodyPr/>
                    <a:lstStyle/>
                    <a:p>
                      <a:pPr algn="l" fontAlgn="b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=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7957962"/>
                  </a:ext>
                </a:extLst>
              </a:tr>
              <a:tr h="14473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,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9701"/>
                  </a:ext>
                </a:extLst>
              </a:tr>
              <a:tr h="144730">
                <a:tc>
                  <a:txBody>
                    <a:bodyPr/>
                    <a:lstStyle/>
                    <a:p>
                      <a:pPr algn="l" fontAlgn="b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dia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5658888"/>
                  </a:ext>
                </a:extLst>
              </a:tr>
              <a:tr h="144730">
                <a:tc>
                  <a:txBody>
                    <a:bodyPr/>
                    <a:lstStyle/>
                    <a:p>
                      <a:pPr algn="l" fontAlgn="b"/>
                      <a:r>
                        <a:rPr lang="en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ng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-61 years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59606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598094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983EFFD-2AB5-C446-80E1-5A422F1FC709}"/>
              </a:ext>
            </a:extLst>
          </p:cNvPr>
          <p:cNvSpPr txBox="1"/>
          <p:nvPr/>
        </p:nvSpPr>
        <p:spPr>
          <a:xfrm>
            <a:off x="180487" y="165613"/>
            <a:ext cx="2540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4983DAE4-30CB-8048-A7F5-793E34BCBB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3981126"/>
              </p:ext>
            </p:extLst>
          </p:nvPr>
        </p:nvGraphicFramePr>
        <p:xfrm>
          <a:off x="471488" y="645383"/>
          <a:ext cx="5915023" cy="2180314"/>
        </p:xfrm>
        <a:graphic>
          <a:graphicData uri="http://schemas.openxmlformats.org/drawingml/2006/table">
            <a:tbl>
              <a:tblPr/>
              <a:tblGrid>
                <a:gridCol w="1303178">
                  <a:extLst>
                    <a:ext uri="{9D8B030D-6E8A-4147-A177-3AD203B41FA5}">
                      <a16:colId xmlns:a16="http://schemas.microsoft.com/office/drawing/2014/main" val="3463503272"/>
                    </a:ext>
                  </a:extLst>
                </a:gridCol>
                <a:gridCol w="991039">
                  <a:extLst>
                    <a:ext uri="{9D8B030D-6E8A-4147-A177-3AD203B41FA5}">
                      <a16:colId xmlns:a16="http://schemas.microsoft.com/office/drawing/2014/main" val="2326576091"/>
                    </a:ext>
                  </a:extLst>
                </a:gridCol>
                <a:gridCol w="905202">
                  <a:extLst>
                    <a:ext uri="{9D8B030D-6E8A-4147-A177-3AD203B41FA5}">
                      <a16:colId xmlns:a16="http://schemas.microsoft.com/office/drawing/2014/main" val="4205036560"/>
                    </a:ext>
                  </a:extLst>
                </a:gridCol>
                <a:gridCol w="678901">
                  <a:extLst>
                    <a:ext uri="{9D8B030D-6E8A-4147-A177-3AD203B41FA5}">
                      <a16:colId xmlns:a16="http://schemas.microsoft.com/office/drawing/2014/main" val="1871311059"/>
                    </a:ext>
                  </a:extLst>
                </a:gridCol>
                <a:gridCol w="678901">
                  <a:extLst>
                    <a:ext uri="{9D8B030D-6E8A-4147-A177-3AD203B41FA5}">
                      <a16:colId xmlns:a16="http://schemas.microsoft.com/office/drawing/2014/main" val="3729754588"/>
                    </a:ext>
                  </a:extLst>
                </a:gridCol>
                <a:gridCol w="678901">
                  <a:extLst>
                    <a:ext uri="{9D8B030D-6E8A-4147-A177-3AD203B41FA5}">
                      <a16:colId xmlns:a16="http://schemas.microsoft.com/office/drawing/2014/main" val="4128266404"/>
                    </a:ext>
                  </a:extLst>
                </a:gridCol>
                <a:gridCol w="678901">
                  <a:extLst>
                    <a:ext uri="{9D8B030D-6E8A-4147-A177-3AD203B41FA5}">
                      <a16:colId xmlns:a16="http://schemas.microsoft.com/office/drawing/2014/main" val="3703614542"/>
                    </a:ext>
                  </a:extLst>
                </a:gridCol>
              </a:tblGrid>
              <a:tr h="3964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D 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value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TC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YR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fference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 of difference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9386907"/>
                  </a:ext>
                </a:extLst>
              </a:tr>
              <a:tr h="1773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21667836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MT8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,20E-3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594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8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514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3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6407729"/>
                  </a:ext>
                </a:extLst>
              </a:tr>
              <a:tr h="1773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25221625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YBB3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,05E-3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77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299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7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27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3076333"/>
                  </a:ext>
                </a:extLst>
              </a:tr>
              <a:tr h="1773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02254461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SRNP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,60E-25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746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276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7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34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3417087"/>
                  </a:ext>
                </a:extLst>
              </a:tr>
              <a:tr h="1773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07823492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XB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46E-29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795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333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6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29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7229225"/>
                  </a:ext>
                </a:extLst>
              </a:tr>
              <a:tr h="1773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15518950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MEM17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,86E-23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638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197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4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34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9867160"/>
                  </a:ext>
                </a:extLst>
              </a:tr>
              <a:tr h="1773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16698623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MT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,28E-3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718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28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38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26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9939900"/>
                  </a:ext>
                </a:extLst>
              </a:tr>
              <a:tr h="1773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17686260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MT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49E-23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694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26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34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33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5701680"/>
                  </a:ext>
                </a:extLst>
              </a:tr>
              <a:tr h="1773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01169778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BGT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85E-24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68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253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27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32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7150934"/>
                  </a:ext>
                </a:extLst>
              </a:tr>
              <a:tr h="1773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18854666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LC11A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,45E-25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75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334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18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30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6982426"/>
                  </a:ext>
                </a:extLst>
              </a:tr>
              <a:tr h="1877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23653187</a:t>
                      </a:r>
                    </a:p>
                  </a:txBody>
                  <a:tcPr marL="7824" marR="7824" marT="782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NPLA3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,23E-3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76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61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415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T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025</a:t>
                      </a:r>
                    </a:p>
                  </a:txBody>
                  <a:tcPr marL="7824" marR="7824" marT="7824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4368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229804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4">
            <a:extLst>
              <a:ext uri="{FF2B5EF4-FFF2-40B4-BE49-F238E27FC236}">
                <a16:creationId xmlns:a16="http://schemas.microsoft.com/office/drawing/2014/main" id="{E89081A3-3914-2044-AD21-08102BC442C7}"/>
              </a:ext>
            </a:extLst>
          </p:cNvPr>
          <p:cNvSpPr txBox="1"/>
          <p:nvPr/>
        </p:nvSpPr>
        <p:spPr>
          <a:xfrm>
            <a:off x="550333" y="772597"/>
            <a:ext cx="2540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Table 4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91E7EC2-B738-9540-B6D8-CADFDEFB31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690908"/>
              </p:ext>
            </p:extLst>
          </p:nvPr>
        </p:nvGraphicFramePr>
        <p:xfrm>
          <a:off x="471488" y="1316038"/>
          <a:ext cx="5742276" cy="1748962"/>
        </p:xfrm>
        <a:graphic>
          <a:graphicData uri="http://schemas.openxmlformats.org/drawingml/2006/table">
            <a:tbl>
              <a:tblPr/>
              <a:tblGrid>
                <a:gridCol w="1372997">
                  <a:extLst>
                    <a:ext uri="{9D8B030D-6E8A-4147-A177-3AD203B41FA5}">
                      <a16:colId xmlns:a16="http://schemas.microsoft.com/office/drawing/2014/main" val="3088311093"/>
                    </a:ext>
                  </a:extLst>
                </a:gridCol>
                <a:gridCol w="3184715">
                  <a:extLst>
                    <a:ext uri="{9D8B030D-6E8A-4147-A177-3AD203B41FA5}">
                      <a16:colId xmlns:a16="http://schemas.microsoft.com/office/drawing/2014/main" val="1368874669"/>
                    </a:ext>
                  </a:extLst>
                </a:gridCol>
                <a:gridCol w="1184564">
                  <a:extLst>
                    <a:ext uri="{9D8B030D-6E8A-4147-A177-3AD203B41FA5}">
                      <a16:colId xmlns:a16="http://schemas.microsoft.com/office/drawing/2014/main" val="566835367"/>
                    </a:ext>
                  </a:extLst>
                </a:gridCol>
              </a:tblGrid>
              <a:tr h="1670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imer/Probe Name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imer/Probe Sequence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nal concentration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2753717"/>
                  </a:ext>
                </a:extLst>
              </a:tr>
              <a:tr h="15721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7x-Rv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A GTT CCT CCT ACT GGG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4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5806385"/>
                  </a:ext>
                </a:extLst>
              </a:tr>
              <a:tr h="15721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7x-Fw1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A CAG GGA GAA GAG CC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7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3456889"/>
                  </a:ext>
                </a:extLst>
              </a:tr>
              <a:tr h="15721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7x-Fw2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T GAG AGG AAG AAG TAC ATG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6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9279224"/>
                  </a:ext>
                </a:extLst>
              </a:tr>
              <a:tr h="15721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7x-Fw3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AA GGA GAT GGG CTT GG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0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5391491"/>
                  </a:ext>
                </a:extLst>
              </a:tr>
              <a:tr h="15721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7x-Short-FA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56-FAM/AG CAT CTG A/ZEN/A TCC TTG GGC C/3IABkFQ/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4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8118153"/>
                  </a:ext>
                </a:extLst>
              </a:tr>
              <a:tr h="15721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7x-Medium-FA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56-FAM/TC CAG TGA G/ZEN/A TGA GCC CCA /3IABkFQ/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4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5777087"/>
                  </a:ext>
                </a:extLst>
              </a:tr>
              <a:tr h="15721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7X-Long-HEX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5HEX/TG CAG GAG G/ZEN/T TCA CCA GC/3IABkFQ/ 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8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2148521"/>
                  </a:ext>
                </a:extLst>
              </a:tr>
              <a:tr h="15721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6-Fw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G CAT TGT CCC ACA G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3147039"/>
                  </a:ext>
                </a:extLst>
              </a:tr>
              <a:tr h="15721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6-Rv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T GGT GGT CAT CGT C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6470507"/>
                  </a:ext>
                </a:extLst>
              </a:tr>
              <a:tr h="1670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6-D419-HEX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5HEX/TG GCA TTG T/ZEN/T GTC TTG GTT G/3IABkFQ/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 µM</a:t>
                      </a:r>
                    </a:p>
                  </a:txBody>
                  <a:tcPr marL="7369" marR="7369" marT="73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35944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373661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4">
            <a:extLst>
              <a:ext uri="{FF2B5EF4-FFF2-40B4-BE49-F238E27FC236}">
                <a16:creationId xmlns:a16="http://schemas.microsoft.com/office/drawing/2014/main" id="{F7CA7181-1984-A54F-B787-821637E03EE7}"/>
              </a:ext>
            </a:extLst>
          </p:cNvPr>
          <p:cNvSpPr txBox="1"/>
          <p:nvPr/>
        </p:nvSpPr>
        <p:spPr>
          <a:xfrm>
            <a:off x="550333" y="772597"/>
            <a:ext cx="2540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pplementary Table 5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451DB97-34BB-AC41-97D8-9F06BD00ABB5}"/>
              </a:ext>
            </a:extLst>
          </p:cNvPr>
          <p:cNvGraphicFramePr>
            <a:graphicFrameLocks noGrp="1"/>
          </p:cNvGraphicFramePr>
          <p:nvPr/>
        </p:nvGraphicFramePr>
        <p:xfrm>
          <a:off x="596900" y="1275862"/>
          <a:ext cx="5664200" cy="838200"/>
        </p:xfrm>
        <a:graphic>
          <a:graphicData uri="http://schemas.openxmlformats.org/drawingml/2006/table">
            <a:tbl>
              <a:tblPr/>
              <a:tblGrid>
                <a:gridCol w="2146300">
                  <a:extLst>
                    <a:ext uri="{9D8B030D-6E8A-4147-A177-3AD203B41FA5}">
                      <a16:colId xmlns:a16="http://schemas.microsoft.com/office/drawing/2014/main" val="3692229079"/>
                    </a:ext>
                  </a:extLst>
                </a:gridCol>
                <a:gridCol w="3517900">
                  <a:extLst>
                    <a:ext uri="{9D8B030D-6E8A-4147-A177-3AD203B41FA5}">
                      <a16:colId xmlns:a16="http://schemas.microsoft.com/office/drawing/2014/main" val="370821546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imer/Probe Nam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imer/Probe Sequenc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974613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MT CG_16698623 FW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'- GGTTGGATTATTGTATTTGGT - 3'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711316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MT CG_16698623 RE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'- TTATACAACACATTTCCACTCA- 3'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6774326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GMT CG_16698623 PROB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'- TTGACGAGTTATGTTAGAT- 3'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48505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32405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 2013-2022">
  <a:themeElements>
    <a:clrScheme name="Tema di Office 2013-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 2013-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 2013-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 2013-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14</TotalTime>
  <Words>822</Words>
  <Application>Microsoft Macintosh PowerPoint</Application>
  <PresentationFormat>A4 Paper (210x297 mm)</PresentationFormat>
  <Paragraphs>360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Palatino Linotype</vt:lpstr>
      <vt:lpstr>Tema di Office 2013-2022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na citarella</dc:creator>
  <cp:lastModifiedBy>Agnese Po</cp:lastModifiedBy>
  <cp:revision>44</cp:revision>
  <cp:lastPrinted>2023-05-17T09:40:57Z</cp:lastPrinted>
  <dcterms:created xsi:type="dcterms:W3CDTF">2023-01-20T11:48:59Z</dcterms:created>
  <dcterms:modified xsi:type="dcterms:W3CDTF">2023-08-31T11:44:13Z</dcterms:modified>
</cp:coreProperties>
</file>